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3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41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00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636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667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56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683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832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556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172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847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256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598BD-A1ED-46E4-B838-031AFB59E6E1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079AE-683A-4406-B963-F26AD6BABB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111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244749" y="869522"/>
            <a:ext cx="3000419" cy="1405681"/>
            <a:chOff x="244749" y="869522"/>
            <a:chExt cx="3000419" cy="140568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950" y="966439"/>
              <a:ext cx="2883218" cy="1143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318307" y="869522"/>
              <a:ext cx="10995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OVCAR-4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-137024" y="1414828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ell viability, %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316762" y="2028982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Rx0237, µM</a:t>
              </a:r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3244997" y="869522"/>
            <a:ext cx="3006329" cy="1405681"/>
            <a:chOff x="3244997" y="869522"/>
            <a:chExt cx="3006329" cy="140568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8108" y="966439"/>
              <a:ext cx="2883218" cy="11430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4341997" y="869522"/>
              <a:ext cx="11163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OVCAR4-PR2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863224" y="1418787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ell viability, %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304833" y="2028982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Rx0237, µM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250840" y="2857865"/>
            <a:ext cx="2994328" cy="1436175"/>
            <a:chOff x="250840" y="2857865"/>
            <a:chExt cx="2994328" cy="143617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950" y="2980976"/>
              <a:ext cx="2883218" cy="11430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267818" y="2857865"/>
              <a:ext cx="11163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STOSE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-130933" y="3503490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ell viability, %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237901" y="4047819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Rx0237, µM</a:t>
              </a: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3267873" y="2826369"/>
            <a:ext cx="2994328" cy="1428226"/>
            <a:chOff x="3021386" y="2826369"/>
            <a:chExt cx="2994328" cy="1428226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2496" y="2928588"/>
              <a:ext cx="2883218" cy="11430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072264" y="2826369"/>
              <a:ext cx="11163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STOSE-PR25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639613" y="3429366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ell viability, %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027637" y="4008374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Rx0237, µM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6255595" y="2857865"/>
            <a:ext cx="2983890" cy="1396729"/>
            <a:chOff x="5802370" y="2857865"/>
            <a:chExt cx="2983890" cy="139672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3042" y="2928588"/>
              <a:ext cx="2883218" cy="11430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6854030" y="2857865"/>
              <a:ext cx="11163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STOSE-PR5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5420597" y="3473840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ell viability, %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798183" y="4008373"/>
              <a:ext cx="100976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TRx0237, µM</a:t>
              </a: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2059387" y="1537938"/>
            <a:ext cx="1062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C50=6.7±0.2µM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066305" y="1581150"/>
            <a:ext cx="10626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C50=8.6±0.9µM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047530" y="3596950"/>
            <a:ext cx="1156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C50=29.0±2.1µM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901894" y="3552476"/>
            <a:ext cx="1156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C50=36.6±3.2µM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987265" y="3585790"/>
            <a:ext cx="1156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C50=60.2±6.3µM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6861" y="5117690"/>
            <a:ext cx="90455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IC50 for TRx0237. Values of IC50 for TRx0237 in OVCAR-4, STOSE, and their paclitaxel-resistant clones were calculated using the IC50 calculator tool at attbio.com; error bars were generated based on the standard error of the mean (SEM).</a:t>
            </a:r>
          </a:p>
        </p:txBody>
      </p:sp>
    </p:spTree>
    <p:extLst>
      <p:ext uri="{BB962C8B-B14F-4D97-AF65-F5344CB8AC3E}">
        <p14:creationId xmlns:p14="http://schemas.microsoft.com/office/powerpoint/2010/main" val="1167564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94</Words>
  <Application>Microsoft Office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MDPI</cp:lastModifiedBy>
  <cp:revision>8</cp:revision>
  <dcterms:created xsi:type="dcterms:W3CDTF">2022-08-20T19:37:31Z</dcterms:created>
  <dcterms:modified xsi:type="dcterms:W3CDTF">2022-09-20T02:25:37Z</dcterms:modified>
</cp:coreProperties>
</file>